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4"/>
  </p:notesMasterIdLst>
  <p:sldIdLst>
    <p:sldId id="276" r:id="rId2"/>
    <p:sldId id="262" r:id="rId3"/>
    <p:sldId id="261" r:id="rId4"/>
    <p:sldId id="277" r:id="rId5"/>
    <p:sldId id="267" r:id="rId6"/>
    <p:sldId id="268" r:id="rId7"/>
    <p:sldId id="266" r:id="rId8"/>
    <p:sldId id="275" r:id="rId9"/>
    <p:sldId id="269" r:id="rId10"/>
    <p:sldId id="279" r:id="rId11"/>
    <p:sldId id="273" r:id="rId12"/>
    <p:sldId id="274" r:id="rId1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58A89"/>
    <a:srgbClr val="4CC9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38"/>
    <p:restoredTop sz="96289"/>
  </p:normalViewPr>
  <p:slideViewPr>
    <p:cSldViewPr snapToGrid="0" snapToObjects="1">
      <p:cViewPr>
        <p:scale>
          <a:sx n="91" d="100"/>
          <a:sy n="91" d="100"/>
        </p:scale>
        <p:origin x="2064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ECAC34-10C9-6F49-B6E5-ABD60BB05DCD}" type="datetimeFigureOut">
              <a:rPr lang="en-US" smtClean="0"/>
              <a:t>6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341D0C-C061-0B4E-B0C8-CF441D933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8286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4390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0382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entrality metrics and nois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8158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4647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effectLst/>
              </a:rPr>
              <a:t>No single centrality metric can distinguish driver TFs</a:t>
            </a:r>
            <a:endParaRPr lang="en-US" dirty="0">
              <a:effectLst/>
            </a:endParaRPr>
          </a:p>
          <a:p>
            <a:endParaRPr lang="en-US" dirty="0"/>
          </a:p>
          <a:p>
            <a:r>
              <a:rPr lang="en-US" dirty="0"/>
              <a:t>A: full network</a:t>
            </a:r>
          </a:p>
          <a:p>
            <a:r>
              <a:rPr lang="en-US" dirty="0"/>
              <a:t>B: </a:t>
            </a:r>
            <a:r>
              <a:rPr lang="en-US" dirty="0" err="1"/>
              <a:t>ct</a:t>
            </a:r>
            <a:r>
              <a:rPr lang="en-US" dirty="0"/>
              <a:t>-specific network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6438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F approach to centrality importa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72204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55194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41D0C-C061-0B4E-B0C8-CF441D93335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856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8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028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460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405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051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46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4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554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840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626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26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49102-5539-0541-AA79-E1104DC715E9}" type="datetimeFigureOut">
              <a:rPr lang="en-US" smtClean="0"/>
              <a:t>6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D9913-C05F-3948-8F9E-5EB0DA904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140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F0A9DDF-C003-5FF5-DF41-5DE26C6530E5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851C836-BED9-4E59-A96B-ABE652D3F0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9332"/>
            <a:ext cx="6858000" cy="32004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19D7E99-8C1A-6DA3-4712-B7F6819BFFC9}"/>
              </a:ext>
            </a:extLst>
          </p:cNvPr>
          <p:cNvSpPr/>
          <p:nvPr/>
        </p:nvSpPr>
        <p:spPr>
          <a:xfrm>
            <a:off x="-21493" y="262645"/>
            <a:ext cx="389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132106D-2D1B-5E14-04AE-09C045C3D4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558" y="3676419"/>
            <a:ext cx="4572000" cy="27432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5EF2997-6A9B-09AC-BAF1-D421662AF3F8}"/>
              </a:ext>
            </a:extLst>
          </p:cNvPr>
          <p:cNvSpPr/>
          <p:nvPr/>
        </p:nvSpPr>
        <p:spPr>
          <a:xfrm>
            <a:off x="-21493" y="3491753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</p:spTree>
    <p:extLst>
      <p:ext uri="{BB962C8B-B14F-4D97-AF65-F5344CB8AC3E}">
        <p14:creationId xmlns:p14="http://schemas.microsoft.com/office/powerpoint/2010/main" val="1137868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4840E14-DB5A-D859-A3D8-CCB44FEED7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" y="369332"/>
            <a:ext cx="6720840" cy="358444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EA4B0D8-E38B-2963-A596-F39C50E2BB5B}"/>
              </a:ext>
            </a:extLst>
          </p:cNvPr>
          <p:cNvSpPr txBox="1"/>
          <p:nvPr/>
        </p:nvSpPr>
        <p:spPr>
          <a:xfrm>
            <a:off x="0" y="0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</a:t>
            </a:r>
          </a:p>
        </p:txBody>
      </p:sp>
    </p:spTree>
    <p:extLst>
      <p:ext uri="{BB962C8B-B14F-4D97-AF65-F5344CB8AC3E}">
        <p14:creationId xmlns:p14="http://schemas.microsoft.com/office/powerpoint/2010/main" val="36085264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FC9D557-93EE-0AD3-B2ED-8605125F3D15}"/>
              </a:ext>
            </a:extLst>
          </p:cNvPr>
          <p:cNvSpPr txBox="1"/>
          <p:nvPr/>
        </p:nvSpPr>
        <p:spPr>
          <a:xfrm>
            <a:off x="0" y="0"/>
            <a:ext cx="2693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78AF49E9-4B25-FA66-6D85-1FDCE0C43E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0137360"/>
              </p:ext>
            </p:extLst>
          </p:nvPr>
        </p:nvGraphicFramePr>
        <p:xfrm>
          <a:off x="413795" y="466846"/>
          <a:ext cx="6068030" cy="672592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213606">
                  <a:extLst>
                    <a:ext uri="{9D8B030D-6E8A-4147-A177-3AD203B41FA5}">
                      <a16:colId xmlns:a16="http://schemas.microsoft.com/office/drawing/2014/main" val="1987673849"/>
                    </a:ext>
                  </a:extLst>
                </a:gridCol>
                <a:gridCol w="1213606">
                  <a:extLst>
                    <a:ext uri="{9D8B030D-6E8A-4147-A177-3AD203B41FA5}">
                      <a16:colId xmlns:a16="http://schemas.microsoft.com/office/drawing/2014/main" val="3637148564"/>
                    </a:ext>
                  </a:extLst>
                </a:gridCol>
                <a:gridCol w="1213606">
                  <a:extLst>
                    <a:ext uri="{9D8B030D-6E8A-4147-A177-3AD203B41FA5}">
                      <a16:colId xmlns:a16="http://schemas.microsoft.com/office/drawing/2014/main" val="3885333620"/>
                    </a:ext>
                  </a:extLst>
                </a:gridCol>
                <a:gridCol w="1213606">
                  <a:extLst>
                    <a:ext uri="{9D8B030D-6E8A-4147-A177-3AD203B41FA5}">
                      <a16:colId xmlns:a16="http://schemas.microsoft.com/office/drawing/2014/main" val="941144220"/>
                    </a:ext>
                  </a:extLst>
                </a:gridCol>
                <a:gridCol w="1213606">
                  <a:extLst>
                    <a:ext uri="{9D8B030D-6E8A-4147-A177-3AD203B41FA5}">
                      <a16:colId xmlns:a16="http://schemas.microsoft.com/office/drawing/2014/main" val="292262727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work Mode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rajectory 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ransi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# TF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# Target/# HK gen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16345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87754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03855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41332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800/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585874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100/2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27074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r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21196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r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0243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r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58142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r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800/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54962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r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100/2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181510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onsecutive 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66404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onsecutive 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8398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onsecutive 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0/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20175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onsecutive 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800/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526882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et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onsecutive Bifurcat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100/2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44366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959535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FC9D557-93EE-0AD3-B2ED-8605125F3D15}"/>
              </a:ext>
            </a:extLst>
          </p:cNvPr>
          <p:cNvSpPr txBox="1"/>
          <p:nvPr/>
        </p:nvSpPr>
        <p:spPr>
          <a:xfrm>
            <a:off x="0" y="0"/>
            <a:ext cx="2693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99785700-6BFD-B206-B109-0E03118ADF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2896329"/>
              </p:ext>
            </p:extLst>
          </p:nvPr>
        </p:nvGraphicFramePr>
        <p:xfrm>
          <a:off x="348686" y="369332"/>
          <a:ext cx="6160627" cy="862076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2601286">
                  <a:extLst>
                    <a:ext uri="{9D8B030D-6E8A-4147-A177-3AD203B41FA5}">
                      <a16:colId xmlns:a16="http://schemas.microsoft.com/office/drawing/2014/main" val="1987673849"/>
                    </a:ext>
                  </a:extLst>
                </a:gridCol>
                <a:gridCol w="3559341">
                  <a:extLst>
                    <a:ext uri="{9D8B030D-6E8A-4147-A177-3AD203B41FA5}">
                      <a16:colId xmlns:a16="http://schemas.microsoft.com/office/drawing/2014/main" val="363714856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Transi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Gold Standard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16345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B cell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Erythrocyte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 err="1"/>
                        <a:t>Sadahira</a:t>
                      </a:r>
                      <a:r>
                        <a:rPr lang="en-US" sz="1050" dirty="0"/>
                        <a:t> et al. 2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87754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Hepatocyte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Neuron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 err="1"/>
                        <a:t>Marro</a:t>
                      </a:r>
                      <a:r>
                        <a:rPr lang="en-US" sz="1050" dirty="0"/>
                        <a:t> et al. 20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03855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ESC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Takahashi et al. 200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41332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HSPC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Batta et al. 20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585874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Neuron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 err="1"/>
                        <a:t>Vierbuchen</a:t>
                      </a:r>
                      <a:r>
                        <a:rPr lang="en-US" sz="1050" dirty="0"/>
                        <a:t> et al. 20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27074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Pre/Pro B cell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HSPC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Riddell et al. 20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21196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Astrocyte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 err="1"/>
                        <a:t>Caiazzo</a:t>
                      </a:r>
                      <a:r>
                        <a:rPr lang="en-US" sz="1050" dirty="0"/>
                        <a:t> et al. 20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0243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OPC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 err="1"/>
                        <a:t>Najm</a:t>
                      </a:r>
                      <a:r>
                        <a:rPr lang="en-US" sz="1050" dirty="0"/>
                        <a:t> et al. 2013</a:t>
                      </a:r>
                    </a:p>
                    <a:p>
                      <a:r>
                        <a:rPr lang="en-US" sz="1050" dirty="0"/>
                        <a:t>Yang et al. 20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58142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CMP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HSC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Riddell et al. 20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54962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B cell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Macrophage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Bussmann et al. 2009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 err="1"/>
                        <a:t>Xie</a:t>
                      </a:r>
                      <a:r>
                        <a:rPr lang="en-US" sz="1050" dirty="0"/>
                        <a:t> et al. 200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8398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Cardiomyocyte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Song et al. 2012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 err="1"/>
                        <a:t>Ieda</a:t>
                      </a:r>
                      <a:r>
                        <a:rPr lang="en-US" sz="1050" dirty="0"/>
                        <a:t> et al. 2010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Addis et al. 2013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 err="1"/>
                        <a:t>Protze</a:t>
                      </a:r>
                      <a:r>
                        <a:rPr lang="en-US" sz="1050" dirty="0"/>
                        <a:t> et al. 2012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 err="1"/>
                        <a:t>Cristoforou</a:t>
                      </a:r>
                      <a:r>
                        <a:rPr lang="en-US" sz="1050" dirty="0"/>
                        <a:t> et al. 2013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Qian et al. 2012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 err="1"/>
                        <a:t>Inagawa</a:t>
                      </a:r>
                      <a:r>
                        <a:rPr lang="en-US" sz="1050" dirty="0"/>
                        <a:t> et al. 2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032840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Hepatocy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Sekiya and Suzuki 2011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Chen et al. 2018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Park et al. 20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45444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Macrophage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Feng et al. 200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50915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Satellite Cell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Ito et al. 20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97440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Astrocyte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NA Neuron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Li et al. 20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07556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NA Neuron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Li et al. 20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82869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Smooth Muscle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Hirai et al. 20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29431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Dopa Neuron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 err="1"/>
                        <a:t>Caiazzo</a:t>
                      </a:r>
                      <a:r>
                        <a:rPr lang="en-US" sz="1050" dirty="0"/>
                        <a:t> et al. 2011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Sheng et al. 2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20175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dirty="0"/>
                        <a:t>Fibroblast </a:t>
                      </a:r>
                      <a:r>
                        <a:rPr lang="en-US" sz="1050" dirty="0">
                          <a:sym typeface="Wingdings" pitchFamily="2" charset="2"/>
                        </a:rPr>
                        <a:t> NSC</a:t>
                      </a:r>
                      <a:endParaRPr lang="en-US" sz="105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Han et al. 2012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Ring et al. 20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526882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1030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F067768-DFC9-6F4B-9AF1-EDF2E2678179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17DF500-A968-1C41-6F3D-A65943C7DA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776" y="430292"/>
            <a:ext cx="6632448" cy="574812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069B630-FA30-A7A2-C876-DB1C7EAC6B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776" y="6303264"/>
            <a:ext cx="6632448" cy="265297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D4DDA00F-9D51-724C-8228-89D6309ACBA8}"/>
              </a:ext>
            </a:extLst>
          </p:cNvPr>
          <p:cNvSpPr/>
          <p:nvPr/>
        </p:nvSpPr>
        <p:spPr>
          <a:xfrm>
            <a:off x="-21493" y="262645"/>
            <a:ext cx="389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3583C81-FE55-C4F3-5F2A-66ED20EE5F59}"/>
              </a:ext>
            </a:extLst>
          </p:cNvPr>
          <p:cNvSpPr/>
          <p:nvPr/>
        </p:nvSpPr>
        <p:spPr>
          <a:xfrm>
            <a:off x="-21493" y="6056173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</p:spTree>
    <p:extLst>
      <p:ext uri="{BB962C8B-B14F-4D97-AF65-F5344CB8AC3E}">
        <p14:creationId xmlns:p14="http://schemas.microsoft.com/office/powerpoint/2010/main" val="27636276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F067768-DFC9-6F4B-9AF1-EDF2E2678179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AA62CD3-619A-550C-0ED0-3148D4B26D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205" y="369332"/>
            <a:ext cx="6529589" cy="8706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17988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07F467D-E422-35B0-0C7E-E9059EF4FB71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F14493C-B496-456F-2708-DCBCAF04CF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92" y="369332"/>
            <a:ext cx="6759615" cy="31544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77072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9686AF9-56E7-FFC7-EA3C-6005CC4B92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405" y="4636771"/>
            <a:ext cx="6561189" cy="437412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0A698B5-1CA3-5945-386B-8E0E309D04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405" y="262645"/>
            <a:ext cx="6561189" cy="437412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F067768-DFC9-6F4B-9AF1-EDF2E2678179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BFE27BF-F0BC-B6CA-E65A-3A39EABF0C30}"/>
              </a:ext>
            </a:extLst>
          </p:cNvPr>
          <p:cNvSpPr/>
          <p:nvPr/>
        </p:nvSpPr>
        <p:spPr>
          <a:xfrm>
            <a:off x="-21493" y="262645"/>
            <a:ext cx="389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DC0CB89-ADFE-EA18-79DB-BB542147D37C}"/>
              </a:ext>
            </a:extLst>
          </p:cNvPr>
          <p:cNvSpPr/>
          <p:nvPr/>
        </p:nvSpPr>
        <p:spPr>
          <a:xfrm>
            <a:off x="0" y="4558792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</p:spTree>
    <p:extLst>
      <p:ext uri="{BB962C8B-B14F-4D97-AF65-F5344CB8AC3E}">
        <p14:creationId xmlns:p14="http://schemas.microsoft.com/office/powerpoint/2010/main" val="1128814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9EC11B02-B828-E32A-8BC7-3DFBC869BB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929" y="4614229"/>
            <a:ext cx="6578142" cy="438542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47798B4-D59D-002C-51B8-1DB279AB31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929" y="262645"/>
            <a:ext cx="6578142" cy="438542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F067768-DFC9-6F4B-9AF1-EDF2E2678179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05F592B-1CB6-1500-E144-D2173D2A731B}"/>
              </a:ext>
            </a:extLst>
          </p:cNvPr>
          <p:cNvSpPr/>
          <p:nvPr/>
        </p:nvSpPr>
        <p:spPr>
          <a:xfrm>
            <a:off x="-21493" y="262645"/>
            <a:ext cx="389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685CB07-532C-9556-E1E2-2EE263F2FFF4}"/>
              </a:ext>
            </a:extLst>
          </p:cNvPr>
          <p:cNvSpPr/>
          <p:nvPr/>
        </p:nvSpPr>
        <p:spPr>
          <a:xfrm>
            <a:off x="0" y="4558792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</p:spTree>
    <p:extLst>
      <p:ext uri="{BB962C8B-B14F-4D97-AF65-F5344CB8AC3E}">
        <p14:creationId xmlns:p14="http://schemas.microsoft.com/office/powerpoint/2010/main" val="36563836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F067768-DFC9-6F4B-9AF1-EDF2E2678179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217EC75-A878-8FC9-530A-9BC7998E27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3382" y="369332"/>
            <a:ext cx="3424618" cy="410954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F34E24-5D5D-B6CA-D9B8-E95C2CA896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81" y="369332"/>
            <a:ext cx="3424618" cy="4109541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45DF417C-AAAB-A70C-C4AD-5BE174DD5A89}"/>
              </a:ext>
            </a:extLst>
          </p:cNvPr>
          <p:cNvSpPr/>
          <p:nvPr/>
        </p:nvSpPr>
        <p:spPr>
          <a:xfrm>
            <a:off x="-21493" y="262645"/>
            <a:ext cx="389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B7049CD-00F5-3604-427A-3AD4B830B296}"/>
              </a:ext>
            </a:extLst>
          </p:cNvPr>
          <p:cNvSpPr/>
          <p:nvPr/>
        </p:nvSpPr>
        <p:spPr>
          <a:xfrm>
            <a:off x="3355170" y="262645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</p:spTree>
    <p:extLst>
      <p:ext uri="{BB962C8B-B14F-4D97-AF65-F5344CB8AC3E}">
        <p14:creationId xmlns:p14="http://schemas.microsoft.com/office/powerpoint/2010/main" val="31780276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8CF1B28-F78B-B73F-EC0F-9364125B5B9D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6F39B70-DCB8-F1D8-555A-FC6FC28E1472}"/>
              </a:ext>
            </a:extLst>
          </p:cNvPr>
          <p:cNvSpPr txBox="1"/>
          <p:nvPr/>
        </p:nvSpPr>
        <p:spPr>
          <a:xfrm>
            <a:off x="118220" y="1518875"/>
            <a:ext cx="2053767" cy="1485022"/>
          </a:xfrm>
          <a:prstGeom prst="rect">
            <a:avLst/>
          </a:prstGeom>
          <a:noFill/>
          <a:ln w="19050"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 sz="1050" u="sng" dirty="0">
                <a:latin typeface="Arial" panose="020B0604020202020204" pitchFamily="34" charset="0"/>
                <a:cs typeface="Arial" panose="020B0604020202020204" pitchFamily="34" charset="0"/>
              </a:rPr>
              <a:t>Transition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broblas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 cardiomyocyt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Fibroblast  HSPC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Fibroblast  hepatocyt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Fibroblast  macrophag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Fibroblast  neur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Fibroblast  ESC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B cell  macrophag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Hepatocyte  neur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E4D89A-74D8-BB98-096F-FAA663DA91FC}"/>
              </a:ext>
            </a:extLst>
          </p:cNvPr>
          <p:cNvSpPr txBox="1"/>
          <p:nvPr/>
        </p:nvSpPr>
        <p:spPr>
          <a:xfrm>
            <a:off x="2780761" y="468587"/>
            <a:ext cx="2129567" cy="2100575"/>
          </a:xfrm>
          <a:prstGeom prst="rect">
            <a:avLst/>
          </a:prstGeom>
          <a:noFill/>
          <a:ln w="19050"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u="sng" dirty="0">
                <a:latin typeface="Arial" panose="020B0604020202020204" pitchFamily="34" charset="0"/>
                <a:cs typeface="Arial" panose="020B0604020202020204" pitchFamily="34" charset="0"/>
              </a:rPr>
              <a:t>Centrality-based feature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ut degre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tal degre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tweenne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losene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agerank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ach-2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ach-3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ub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thor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lusterrank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aplacia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everag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00BA31E-AECD-D8EA-6657-2BB0B75344CE}"/>
              </a:ext>
            </a:extLst>
          </p:cNvPr>
          <p:cNvSpPr txBox="1"/>
          <p:nvPr/>
        </p:nvSpPr>
        <p:spPr>
          <a:xfrm>
            <a:off x="2306476" y="1999776"/>
            <a:ext cx="39466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A9A973-3765-34A6-7CB7-608D40E210DD}"/>
              </a:ext>
            </a:extLst>
          </p:cNvPr>
          <p:cNvSpPr txBox="1"/>
          <p:nvPr/>
        </p:nvSpPr>
        <p:spPr>
          <a:xfrm>
            <a:off x="2780761" y="2796907"/>
            <a:ext cx="2129567" cy="1485022"/>
          </a:xfrm>
          <a:prstGeom prst="rect">
            <a:avLst/>
          </a:prstGeom>
          <a:noFill/>
          <a:ln w="19050"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u="sng" dirty="0">
                <a:latin typeface="Arial" panose="020B0604020202020204" pitchFamily="34" charset="0"/>
                <a:cs typeface="Arial" panose="020B0604020202020204" pitchFamily="34" charset="0"/>
              </a:rPr>
              <a:t>Expression-based feature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an source express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an target express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an source expression ran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an target expression ran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ESe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ESe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-value ran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FC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FC ran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29DB27-72A7-28F7-85B6-E5FA48F2532E}"/>
              </a:ext>
            </a:extLst>
          </p:cNvPr>
          <p:cNvSpPr txBox="1"/>
          <p:nvPr/>
        </p:nvSpPr>
        <p:spPr>
          <a:xfrm>
            <a:off x="4976254" y="1999776"/>
            <a:ext cx="53732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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470F8E3-9BF0-ABA4-EA90-6DD3E1831AEA}"/>
              </a:ext>
            </a:extLst>
          </p:cNvPr>
          <p:cNvSpPr txBox="1"/>
          <p:nvPr/>
        </p:nvSpPr>
        <p:spPr>
          <a:xfrm>
            <a:off x="5513581" y="2134428"/>
            <a:ext cx="1226199" cy="253916"/>
          </a:xfrm>
          <a:prstGeom prst="rect">
            <a:avLst/>
          </a:prstGeom>
          <a:noFill/>
          <a:ln w="19050">
            <a:solidFill>
              <a:schemeClr val="tx1">
                <a:lumMod val="75000"/>
                <a:lumOff val="2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RF Classification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8AFDE91-C655-3B49-8A12-75174A3D66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408" y="4688278"/>
            <a:ext cx="6574420" cy="2465408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D08263BB-4785-400A-DF27-3CC8E4B56C01}"/>
              </a:ext>
            </a:extLst>
          </p:cNvPr>
          <p:cNvSpPr/>
          <p:nvPr/>
        </p:nvSpPr>
        <p:spPr>
          <a:xfrm>
            <a:off x="-21493" y="262645"/>
            <a:ext cx="389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9E6F46E-10BF-7414-A578-C7D46C93C4A7}"/>
              </a:ext>
            </a:extLst>
          </p:cNvPr>
          <p:cNvSpPr/>
          <p:nvPr/>
        </p:nvSpPr>
        <p:spPr>
          <a:xfrm>
            <a:off x="-21493" y="4503086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</p:spTree>
    <p:extLst>
      <p:ext uri="{BB962C8B-B14F-4D97-AF65-F5344CB8AC3E}">
        <p14:creationId xmlns:p14="http://schemas.microsoft.com/office/powerpoint/2010/main" val="27367844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79681F25-0C73-4BC6-CD3C-2D29669F7B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16" y="5732759"/>
            <a:ext cx="6739168" cy="314494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264C4BC-55DE-F5D1-D140-8A41104233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33" y="300465"/>
            <a:ext cx="6805534" cy="272221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63A4965-6268-C9A9-FC97-1B78EB7E381F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DB802DD-3BFE-B7DC-76C4-32D21DBAFF00}"/>
              </a:ext>
            </a:extLst>
          </p:cNvPr>
          <p:cNvSpPr/>
          <p:nvPr/>
        </p:nvSpPr>
        <p:spPr>
          <a:xfrm>
            <a:off x="-21493" y="262645"/>
            <a:ext cx="389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D311AB4-665F-574F-5A94-7B06132CC44C}"/>
              </a:ext>
            </a:extLst>
          </p:cNvPr>
          <p:cNvSpPr/>
          <p:nvPr/>
        </p:nvSpPr>
        <p:spPr>
          <a:xfrm>
            <a:off x="-13479" y="3142800"/>
            <a:ext cx="4026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5416FE8-9347-4514-EFB3-A80BB2F4E64E}"/>
              </a:ext>
            </a:extLst>
          </p:cNvPr>
          <p:cNvSpPr/>
          <p:nvPr/>
        </p:nvSpPr>
        <p:spPr>
          <a:xfrm>
            <a:off x="-21493" y="5736920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EB13533-095A-BBD5-253A-FC38819A9962}"/>
              </a:ext>
            </a:extLst>
          </p:cNvPr>
          <p:cNvSpPr/>
          <p:nvPr/>
        </p:nvSpPr>
        <p:spPr>
          <a:xfrm>
            <a:off x="3330512" y="3138639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EFF9C2B-78E0-D618-BAAA-36292CECD8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691" y="3236261"/>
            <a:ext cx="3210309" cy="240773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83C3478-3719-1664-8C5C-C7E949D80B1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5092" y="3236261"/>
            <a:ext cx="3210309" cy="2407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8304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852</TotalTime>
  <Words>475</Words>
  <Application>Microsoft Macintosh PowerPoint</Application>
  <PresentationFormat>Letter Paper (8.5x11 in)</PresentationFormat>
  <Paragraphs>208</Paragraphs>
  <Slides>12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Su</dc:creator>
  <cp:lastModifiedBy>Patrick Cahan</cp:lastModifiedBy>
  <cp:revision>224</cp:revision>
  <dcterms:created xsi:type="dcterms:W3CDTF">2021-03-01T16:15:39Z</dcterms:created>
  <dcterms:modified xsi:type="dcterms:W3CDTF">2026-06-10T19:27:14Z</dcterms:modified>
</cp:coreProperties>
</file>